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8999538" cy="129635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38480" y="685440"/>
            <a:ext cx="23810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r>
              <a:rPr b="0" lang="en-US" sz="90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2324B9-37D1-4CBF-922D-1A27AF726DB5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ldImg"/>
          </p:nvPr>
        </p:nvSpPr>
        <p:spPr>
          <a:xfrm>
            <a:off x="2238480" y="685800"/>
            <a:ext cx="2381040" cy="3429000"/>
          </a:xfrm>
          <a:prstGeom prst="rect">
            <a:avLst/>
          </a:prstGeom>
          <a:ln w="0">
            <a:noFill/>
          </a:ln>
        </p:spPr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1C47C6-E1D2-479E-90FC-9BAB63D35711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89CF0-A67C-4936-AC9B-5C2F7054A6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48920" y="3022560"/>
            <a:ext cx="810252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48920" y="7491240"/>
            <a:ext cx="810252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CF328-F101-4AF3-9AF0-3EDF01D1F1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48920" y="302256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00800" y="302256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48920" y="749124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00800" y="749124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8E394E-32B7-45FB-A653-FCCE8EB515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48920" y="3022560"/>
            <a:ext cx="260892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 fontScale="95000"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188520" y="3022560"/>
            <a:ext cx="260892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 fontScale="95000"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28480" y="3022560"/>
            <a:ext cx="260892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 fontScale="95000"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48920" y="7491240"/>
            <a:ext cx="260892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 fontScale="95000"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188520" y="7491240"/>
            <a:ext cx="260892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 fontScale="95000"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28480" y="7491240"/>
            <a:ext cx="260892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 fontScale="95000"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65CB4-9A01-45F5-AA70-B72C019ACF6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48920" y="3022560"/>
            <a:ext cx="8102520" cy="855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650"/>
              </a:spcBef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67560-498C-4609-A4D4-9931E1648C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48920" y="3022560"/>
            <a:ext cx="8102520" cy="855504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4A98C-E956-41AF-A248-091FA4A285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48920" y="3022560"/>
            <a:ext cx="3953880" cy="855504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00800" y="3022560"/>
            <a:ext cx="3953880" cy="855504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5A056-1336-4731-8D6C-2E9E2B0EE3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2E72B-A0C4-4878-A6C7-59387DA386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48920" y="517320"/>
            <a:ext cx="8102520" cy="1000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650"/>
              </a:spcBef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29B68-AAEB-4DEF-8601-2FD4EB61EC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48920" y="302256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00800" y="3022560"/>
            <a:ext cx="3953880" cy="855504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48920" y="749124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9F023-D4D1-4BE3-BF2B-0ECC2A4326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48920" y="3022560"/>
            <a:ext cx="3953880" cy="855504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00800" y="302256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00800" y="749124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3F0D1-3572-47DB-9419-2CDAD9EBA3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48920" y="131400"/>
            <a:ext cx="8102520" cy="293076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48920" y="302256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00800" y="3022560"/>
            <a:ext cx="395388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48920" y="7491240"/>
            <a:ext cx="8102520" cy="40806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/>
          </a:bodyPr>
          <a:p>
            <a:pPr indent="0">
              <a:spcBef>
                <a:spcPts val="1650"/>
              </a:spcBef>
              <a:buNone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180B8-2402-46BB-A688-061A27AB0A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48920" y="517320"/>
            <a:ext cx="8102520" cy="215892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ctr">
            <a:noAutofit/>
          </a:bodyPr>
          <a:p>
            <a:pPr indent="0" algn="ctr">
              <a:buNone/>
              <a:tabLst>
                <a:tab algn="l" pos="0"/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r>
              <a:rPr b="0" lang="en-US" sz="90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9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48920" y="3022560"/>
            <a:ext cx="8102520" cy="855504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rmAutofit fontScale="67000"/>
          </a:bodyPr>
          <a:p>
            <a:pPr marL="469800" indent="-469800">
              <a:spcBef>
                <a:spcPts val="1650"/>
              </a:spcBef>
              <a:buClr>
                <a:srgbClr val="000000"/>
              </a:buClr>
              <a:buFont typeface="Arial"/>
              <a:buChar char="•"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  <a:p>
            <a:pPr lvl="1" marL="1018800" indent="-391320">
              <a:spcBef>
                <a:spcPts val="1650"/>
              </a:spcBef>
              <a:buClr>
                <a:srgbClr val="000000"/>
              </a:buClr>
              <a:buFont typeface="Arial"/>
              <a:buChar char="–"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  <a:p>
            <a:pPr lvl="2" marL="1567800" indent="-313560">
              <a:spcBef>
                <a:spcPts val="1650"/>
              </a:spcBef>
              <a:buClr>
                <a:srgbClr val="000000"/>
              </a:buClr>
              <a:buFont typeface="Arial"/>
              <a:buChar char="•"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  <a:p>
            <a:pPr lvl="3" marL="2195280" indent="-313560">
              <a:spcBef>
                <a:spcPts val="1650"/>
              </a:spcBef>
              <a:buClr>
                <a:srgbClr val="000000"/>
              </a:buClr>
              <a:buFont typeface="Arial"/>
              <a:buChar char="–"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  <a:p>
            <a:pPr lvl="4" marL="2822760" indent="-313560">
              <a:spcBef>
                <a:spcPts val="1650"/>
              </a:spcBef>
              <a:buClr>
                <a:srgbClr val="000000"/>
              </a:buClr>
              <a:buFont typeface="Arial"/>
              <a:buChar char="»"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  <a:p>
            <a:pPr lvl="5" marL="2822760" indent="-313560">
              <a:spcBef>
                <a:spcPts val="1650"/>
              </a:spcBef>
              <a:buClr>
                <a:srgbClr val="000000"/>
              </a:buClr>
              <a:buFont typeface="Arial"/>
              <a:buChar char="»"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  <a:p>
            <a:pPr lvl="6" marL="2822760" indent="-313560">
              <a:spcBef>
                <a:spcPts val="1650"/>
              </a:spcBef>
              <a:buClr>
                <a:srgbClr val="000000"/>
              </a:buClr>
              <a:buFont typeface="Arial"/>
              <a:buChar char="»"/>
              <a:tabLst>
                <a:tab algn="l" pos="1871640"/>
                <a:tab algn="l" pos="3743280"/>
                <a:tab algn="l" pos="5614920"/>
                <a:tab algn="l" pos="7486560"/>
                <a:tab algn="l" pos="9358200"/>
              </a:tabLst>
            </a:pPr>
            <a:r>
              <a:rPr b="0" lang="en-US" sz="6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49280" y="11802600"/>
            <a:ext cx="2100240" cy="9018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74760" y="11802600"/>
            <a:ext cx="2850840" cy="9018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1560" y="11802600"/>
            <a:ext cx="2100240" cy="901800"/>
          </a:xfrm>
          <a:prstGeom prst="rect">
            <a:avLst/>
          </a:prstGeom>
          <a:noFill/>
          <a:ln w="0">
            <a:noFill/>
          </a:ln>
        </p:spPr>
        <p:txBody>
          <a:bodyPr lIns="187200" rIns="187200" tIns="93600" bIns="936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2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9C47EB-9802-44FD-8BAF-F373523676FB}" type="slidenum">
              <a:rPr b="0" lang="pt-BR" sz="2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76" descr=""/>
          <p:cNvPicPr/>
          <p:nvPr/>
        </p:nvPicPr>
        <p:blipFill>
          <a:blip r:embed="rId1"/>
          <a:stretch/>
        </p:blipFill>
        <p:spPr>
          <a:xfrm>
            <a:off x="593640" y="6616800"/>
            <a:ext cx="8229600" cy="57513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77" descr=""/>
          <p:cNvPicPr/>
          <p:nvPr/>
        </p:nvPicPr>
        <p:blipFill>
          <a:blip r:embed="rId2"/>
          <a:stretch/>
        </p:blipFill>
        <p:spPr>
          <a:xfrm>
            <a:off x="473040" y="154080"/>
            <a:ext cx="8381880" cy="5759280"/>
          </a:xfrm>
          <a:prstGeom prst="rect">
            <a:avLst/>
          </a:prstGeom>
          <a:ln w="0">
            <a:noFill/>
          </a:ln>
        </p:spPr>
      </p:pic>
      <p:sp>
        <p:nvSpPr>
          <p:cNvPr id="50" name="Text Box 278"/>
          <p:cNvSpPr/>
          <p:nvPr/>
        </p:nvSpPr>
        <p:spPr>
          <a:xfrm>
            <a:off x="2535120" y="12449160"/>
            <a:ext cx="4552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Arial"/>
              </a:rPr>
              <a:t>Xanthomonas citri </a:t>
            </a: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subsp.</a:t>
            </a:r>
            <a:r>
              <a:rPr b="1" i="1" lang="en-US" sz="2400" spc="-1" strike="noStrike">
                <a:solidFill>
                  <a:srgbClr val="000000"/>
                </a:solidFill>
                <a:latin typeface="Arial"/>
              </a:rPr>
              <a:t> citri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79"/>
          <p:cNvSpPr/>
          <p:nvPr/>
        </p:nvSpPr>
        <p:spPr>
          <a:xfrm rot="16200000">
            <a:off x="-2711160" y="9345600"/>
            <a:ext cx="592452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200" spc="-1" strike="noStrike">
                <a:solidFill>
                  <a:srgbClr val="000000"/>
                </a:solidFill>
                <a:latin typeface="Arial"/>
              </a:rPr>
              <a:t>Xanthomonas fuscans </a:t>
            </a: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subsp.</a:t>
            </a:r>
            <a:r>
              <a:rPr b="1" i="1" lang="en-US" sz="2200" spc="-1" strike="noStrike">
                <a:solidFill>
                  <a:srgbClr val="000000"/>
                </a:solidFill>
                <a:latin typeface="Arial"/>
              </a:rPr>
              <a:t> aurantifolii C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80"/>
          <p:cNvSpPr/>
          <p:nvPr/>
        </p:nvSpPr>
        <p:spPr>
          <a:xfrm rot="16200000">
            <a:off x="-2711160" y="2882880"/>
            <a:ext cx="592452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200" spc="-1" strike="noStrike">
                <a:solidFill>
                  <a:srgbClr val="000000"/>
                </a:solidFill>
                <a:latin typeface="Arial"/>
              </a:rPr>
              <a:t>Xanthomonas fuscans </a:t>
            </a:r>
            <a:r>
              <a:rPr b="1" lang="en-US" sz="2200" spc="-1" strike="noStrike">
                <a:solidFill>
                  <a:srgbClr val="000000"/>
                </a:solidFill>
                <a:latin typeface="Arial"/>
              </a:rPr>
              <a:t>subsp.</a:t>
            </a:r>
            <a:r>
              <a:rPr b="1" i="1" lang="en-US" sz="2200" spc="-1" strike="noStrike">
                <a:solidFill>
                  <a:srgbClr val="000000"/>
                </a:solidFill>
                <a:latin typeface="Arial"/>
              </a:rPr>
              <a:t> aurantifolii B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81"/>
          <p:cNvSpPr/>
          <p:nvPr/>
        </p:nvSpPr>
        <p:spPr>
          <a:xfrm>
            <a:off x="2499480" y="5987880"/>
            <a:ext cx="4552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2400" spc="-1" strike="noStrike">
                <a:solidFill>
                  <a:srgbClr val="000000"/>
                </a:solidFill>
                <a:latin typeface="Arial"/>
              </a:rPr>
              <a:t>Xanthomonas citri </a:t>
            </a: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subsp.</a:t>
            </a:r>
            <a:r>
              <a:rPr b="1" i="1" lang="en-US" sz="2400" spc="-1" strike="noStrike">
                <a:solidFill>
                  <a:srgbClr val="000000"/>
                </a:solidFill>
                <a:latin typeface="Arial"/>
              </a:rPr>
              <a:t> citri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82"/>
          <p:cNvSpPr/>
          <p:nvPr/>
        </p:nvSpPr>
        <p:spPr>
          <a:xfrm>
            <a:off x="1279440" y="11553840"/>
            <a:ext cx="763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283"/>
          <p:cNvSpPr/>
          <p:nvPr/>
        </p:nvSpPr>
        <p:spPr>
          <a:xfrm>
            <a:off x="1279440" y="10506240"/>
            <a:ext cx="763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84"/>
          <p:cNvSpPr/>
          <p:nvPr/>
        </p:nvSpPr>
        <p:spPr>
          <a:xfrm>
            <a:off x="1279440" y="9460080"/>
            <a:ext cx="763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85"/>
          <p:cNvSpPr/>
          <p:nvPr/>
        </p:nvSpPr>
        <p:spPr>
          <a:xfrm>
            <a:off x="1279440" y="8337600"/>
            <a:ext cx="763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86"/>
          <p:cNvSpPr/>
          <p:nvPr/>
        </p:nvSpPr>
        <p:spPr>
          <a:xfrm>
            <a:off x="1279440" y="7289640"/>
            <a:ext cx="763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287" descr=""/>
          <p:cNvPicPr/>
          <p:nvPr/>
        </p:nvPicPr>
        <p:blipFill>
          <a:blip r:embed="rId3"/>
          <a:stretch/>
        </p:blipFill>
        <p:spPr>
          <a:xfrm>
            <a:off x="517680" y="11479320"/>
            <a:ext cx="637920" cy="24444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288" descr=""/>
          <p:cNvPicPr/>
          <p:nvPr/>
        </p:nvPicPr>
        <p:blipFill>
          <a:blip r:embed="rId4"/>
          <a:stretch/>
        </p:blipFill>
        <p:spPr>
          <a:xfrm>
            <a:off x="517680" y="10382400"/>
            <a:ext cx="685800" cy="27288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289" descr=""/>
          <p:cNvPicPr/>
          <p:nvPr/>
        </p:nvPicPr>
        <p:blipFill>
          <a:blip r:embed="rId5"/>
          <a:stretch/>
        </p:blipFill>
        <p:spPr>
          <a:xfrm>
            <a:off x="517680" y="9299520"/>
            <a:ext cx="685800" cy="3096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290" descr=""/>
          <p:cNvPicPr/>
          <p:nvPr/>
        </p:nvPicPr>
        <p:blipFill>
          <a:blip r:embed="rId6"/>
          <a:stretch/>
        </p:blipFill>
        <p:spPr>
          <a:xfrm>
            <a:off x="517680" y="8263080"/>
            <a:ext cx="666720" cy="27288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291" descr=""/>
          <p:cNvPicPr/>
          <p:nvPr/>
        </p:nvPicPr>
        <p:blipFill>
          <a:blip r:embed="rId7"/>
          <a:stretch/>
        </p:blipFill>
        <p:spPr>
          <a:xfrm>
            <a:off x="517680" y="7215120"/>
            <a:ext cx="666720" cy="239760"/>
          </a:xfrm>
          <a:prstGeom prst="rect">
            <a:avLst/>
          </a:prstGeom>
          <a:ln w="0">
            <a:noFill/>
          </a:ln>
        </p:spPr>
      </p:pic>
      <p:grpSp>
        <p:nvGrpSpPr>
          <p:cNvPr id="64" name="Grupo 97"/>
          <p:cNvGrpSpPr/>
          <p:nvPr/>
        </p:nvGrpSpPr>
        <p:grpSpPr>
          <a:xfrm>
            <a:off x="5572080" y="3218040"/>
            <a:ext cx="2986200" cy="2329560"/>
            <a:chOff x="5572080" y="3218040"/>
            <a:chExt cx="2986200" cy="2329560"/>
          </a:xfrm>
        </p:grpSpPr>
        <p:pic>
          <p:nvPicPr>
            <p:cNvPr id="65" name="Picture 295" descr=""/>
            <p:cNvPicPr/>
            <p:nvPr/>
          </p:nvPicPr>
          <p:blipFill>
            <a:blip r:embed="rId8"/>
            <a:stretch/>
          </p:blipFill>
          <p:spPr>
            <a:xfrm>
              <a:off x="5572080" y="3218040"/>
              <a:ext cx="2986200" cy="1719720"/>
            </a:xfrm>
            <a:prstGeom prst="rect">
              <a:avLst/>
            </a:prstGeom>
            <a:ln w="3240">
              <a:solidFill>
                <a:srgbClr val="000000"/>
              </a:solidFill>
              <a:miter/>
            </a:ln>
          </p:spPr>
        </p:pic>
        <p:sp>
          <p:nvSpPr>
            <p:cNvPr id="66" name="Text Box 281"/>
            <p:cNvSpPr/>
            <p:nvPr/>
          </p:nvSpPr>
          <p:spPr>
            <a:xfrm>
              <a:off x="5679720" y="4966920"/>
              <a:ext cx="27496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0000"/>
                  </a:solidFill>
                  <a:latin typeface="Arial"/>
                </a:rPr>
                <a:t>Xanthomonas  fuscans subsp. aurantifolii 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7" name="Picture 296" descr=""/>
          <p:cNvPicPr/>
          <p:nvPr/>
        </p:nvPicPr>
        <p:blipFill>
          <a:blip r:embed="rId9"/>
          <a:stretch/>
        </p:blipFill>
        <p:spPr>
          <a:xfrm>
            <a:off x="5584680" y="9752040"/>
            <a:ext cx="2975040" cy="171432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68" name="Conector reto 77"/>
          <p:cNvSpPr/>
          <p:nvPr/>
        </p:nvSpPr>
        <p:spPr>
          <a:xfrm flipH="1">
            <a:off x="7000920" y="3219480"/>
            <a:ext cx="1440" cy="1714320"/>
          </a:xfrm>
          <a:prstGeom prst="line">
            <a:avLst/>
          </a:prstGeom>
          <a:ln w="9360">
            <a:solidFill>
              <a:srgbClr val="d9d9d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Conector reto 78"/>
          <p:cNvSpPr/>
          <p:nvPr/>
        </p:nvSpPr>
        <p:spPr>
          <a:xfrm flipH="1">
            <a:off x="7085160" y="9752040"/>
            <a:ext cx="1440" cy="1714320"/>
          </a:xfrm>
          <a:prstGeom prst="line">
            <a:avLst/>
          </a:prstGeom>
          <a:ln w="9360">
            <a:solidFill>
              <a:srgbClr val="d9d9d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onector reto 129"/>
          <p:cNvSpPr/>
          <p:nvPr/>
        </p:nvSpPr>
        <p:spPr>
          <a:xfrm>
            <a:off x="8286840" y="4503600"/>
            <a:ext cx="285840" cy="1800"/>
          </a:xfrm>
          <a:prstGeom prst="line">
            <a:avLst/>
          </a:prstGeom>
          <a:ln w="38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281"/>
          <p:cNvSpPr/>
          <p:nvPr/>
        </p:nvSpPr>
        <p:spPr>
          <a:xfrm>
            <a:off x="5715000" y="11468160"/>
            <a:ext cx="2749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Xanthomonas  fuscans subsp. aurantifolii 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25T01:16:57Z</dcterms:created>
  <dc:creator>Leandro</dc:creator>
  <dc:description/>
  <dc:language>en-US</dc:language>
  <cp:lastModifiedBy>Leandro</cp:lastModifiedBy>
  <dcterms:modified xsi:type="dcterms:W3CDTF">2009-11-24T17:32:29Z</dcterms:modified>
  <cp:revision>8</cp:revision>
  <dc:subject/>
  <dc:title>Slide 1</dc:title>
</cp:coreProperties>
</file>